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9" d="100"/>
          <a:sy n="109" d="100"/>
        </p:scale>
        <p:origin x="38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0CFC623-0550-4136-93F4-A9F720D4404C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9B0B8AD-20FC-4F15-A76A-C3114F5A57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3100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9B0B8AD-20FC-4F15-A76A-C3114F5A57F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4863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43328-A8B5-4EE5-A14D-C2E0A166BE87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4A2C8-1207-4741-82BC-F5DB11E6B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9047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43328-A8B5-4EE5-A14D-C2E0A166BE87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4A2C8-1207-4741-82BC-F5DB11E6B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3972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43328-A8B5-4EE5-A14D-C2E0A166BE87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4A2C8-1207-4741-82BC-F5DB11E6B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23583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43328-A8B5-4EE5-A14D-C2E0A166BE87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4A2C8-1207-4741-82BC-F5DB11E6B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46448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43328-A8B5-4EE5-A14D-C2E0A166BE87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4A2C8-1207-4741-82BC-F5DB11E6B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3593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43328-A8B5-4EE5-A14D-C2E0A166BE87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4A2C8-1207-4741-82BC-F5DB11E6B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81086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43328-A8B5-4EE5-A14D-C2E0A166BE87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4A2C8-1207-4741-82BC-F5DB11E6B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80255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43328-A8B5-4EE5-A14D-C2E0A166BE87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4A2C8-1207-4741-82BC-F5DB11E6B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52962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43328-A8B5-4EE5-A14D-C2E0A166BE87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4A2C8-1207-4741-82BC-F5DB11E6B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02026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43328-A8B5-4EE5-A14D-C2E0A166BE87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4A2C8-1207-4741-82BC-F5DB11E6B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178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43328-A8B5-4EE5-A14D-C2E0A166BE87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4A2C8-1207-4741-82BC-F5DB11E6B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16461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943328-A8B5-4EE5-A14D-C2E0A166BE87}" type="datetimeFigureOut">
              <a:rPr lang="en-US" smtClean="0"/>
              <a:t>7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B4A2C8-1207-4741-82BC-F5DB11E6B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95451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F:\DCIM\252___03\IMG_9492.JPG"/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50" r="10145"/>
          <a:stretch/>
        </p:blipFill>
        <p:spPr bwMode="auto">
          <a:xfrm>
            <a:off x="8052203" y="520831"/>
            <a:ext cx="2503201" cy="2367333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7" t="1264" r="18563"/>
          <a:stretch/>
        </p:blipFill>
        <p:spPr>
          <a:xfrm>
            <a:off x="2664718" y="520831"/>
            <a:ext cx="2558514" cy="2367333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17" r="5515"/>
          <a:stretch/>
        </p:blipFill>
        <p:spPr>
          <a:xfrm>
            <a:off x="216852" y="520831"/>
            <a:ext cx="2393318" cy="2367333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610170" y="425829"/>
            <a:ext cx="23208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.</a:t>
            </a: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51" t="-268" r="18084" b="5517"/>
          <a:stretch/>
        </p:blipFill>
        <p:spPr>
          <a:xfrm>
            <a:off x="5277780" y="520831"/>
            <a:ext cx="2719875" cy="236733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62305" y="421369"/>
            <a:ext cx="1308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.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217766" y="448201"/>
            <a:ext cx="24121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.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7997655" y="448201"/>
            <a:ext cx="7395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BCD63E0-527A-4D8A-A4E1-D8A27A5EC92D}"/>
              </a:ext>
            </a:extLst>
          </p:cNvPr>
          <p:cNvSpPr txBox="1"/>
          <p:nvPr/>
        </p:nvSpPr>
        <p:spPr>
          <a:xfrm>
            <a:off x="1092820" y="3563930"/>
            <a:ext cx="7939668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2. Effects of external RNA pesticide on inhibiting </a:t>
            </a:r>
            <a:r>
              <a:rPr lang="en-US" i="1" dirty="0"/>
              <a:t>Sclerotinia</a:t>
            </a:r>
            <a:r>
              <a:rPr lang="en-US" dirty="0"/>
              <a:t> </a:t>
            </a:r>
            <a:r>
              <a:rPr lang="en-US" i="1" dirty="0"/>
              <a:t>sclerotiorum </a:t>
            </a:r>
            <a:r>
              <a:rPr lang="en-US" dirty="0"/>
              <a:t>from causing lesions on canola leaves (A) dsRNA targeting agl-2 at 200 ng/20ul, (B) dsRNA targeting agl-2 at 400 ng/20ul, (C) dsRNA targeting agl-2 at 800 ng/20ul, as control (D) dsRNA targeting agl-4 at 800 ng/20ul as control, at 48 hours post inoculation. Statistical comparison is shown in Fig 6C.</a:t>
            </a:r>
          </a:p>
        </p:txBody>
      </p:sp>
    </p:spTree>
    <p:extLst>
      <p:ext uri="{BB962C8B-B14F-4D97-AF65-F5344CB8AC3E}">
        <p14:creationId xmlns:p14="http://schemas.microsoft.com/office/powerpoint/2010/main" val="38041381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</TotalTime>
  <Words>93</Words>
  <Application>Microsoft Office PowerPoint</Application>
  <PresentationFormat>Widescreen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wner</dc:creator>
  <cp:lastModifiedBy>Shinyi Marzano</cp:lastModifiedBy>
  <cp:revision>10</cp:revision>
  <dcterms:created xsi:type="dcterms:W3CDTF">2019-03-26T21:17:50Z</dcterms:created>
  <dcterms:modified xsi:type="dcterms:W3CDTF">2019-07-18T18:41:07Z</dcterms:modified>
</cp:coreProperties>
</file>